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45" d="100"/>
          <a:sy n="45" d="100"/>
        </p:scale>
        <p:origin x="1544" y="44"/>
      </p:cViewPr>
      <p:guideLst>
        <p:guide orient="horz" pos="307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062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1191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0951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51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8853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4313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6600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66569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6280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7573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445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4312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3B88BEA-B9AF-0D23-058F-694C46C455A3}"/>
              </a:ext>
            </a:extLst>
          </p:cNvPr>
          <p:cNvSpPr txBox="1"/>
          <p:nvPr/>
        </p:nvSpPr>
        <p:spPr>
          <a:xfrm>
            <a:off x="5711986" y="50521"/>
            <a:ext cx="1179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I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ikwad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454DE03-7985-E093-2D7F-621FF8C7F04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9650" t="14549" r="24254" b="13370"/>
          <a:stretch/>
        </p:blipFill>
        <p:spPr>
          <a:xfrm>
            <a:off x="1580184" y="1513376"/>
            <a:ext cx="3896056" cy="385019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2C34CDA-6832-2C91-861F-16C06F21EE28}"/>
              </a:ext>
            </a:extLst>
          </p:cNvPr>
          <p:cNvSpPr txBox="1"/>
          <p:nvPr/>
        </p:nvSpPr>
        <p:spPr>
          <a:xfrm>
            <a:off x="1248769" y="6950320"/>
            <a:ext cx="4920019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 Fig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nockdown of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D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N2a cells causes decrease in the RNA levels of Msi2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 siRNA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Dsi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NAs were transfected in N2a cells and the RNA levels of Msi2 RNA were examined by </a:t>
            </a:r>
            <a:b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l-Time PCR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raph showing the decrease in the Msi2 RNA levels</a:t>
            </a:r>
            <a:endParaRPr lang="en-IN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3446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57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ina gaikwad</dc:creator>
  <cp:lastModifiedBy>comp support</cp:lastModifiedBy>
  <cp:revision>25</cp:revision>
  <dcterms:created xsi:type="dcterms:W3CDTF">2022-09-05T06:06:19Z</dcterms:created>
  <dcterms:modified xsi:type="dcterms:W3CDTF">2024-12-01T12:27:45Z</dcterms:modified>
</cp:coreProperties>
</file>